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60" r:id="rId1"/>
  </p:sldMasterIdLst>
  <p:sldIdLst>
    <p:sldId id="257" r:id="rId2"/>
    <p:sldId id="261" r:id="rId3"/>
    <p:sldId id="256" r:id="rId4"/>
    <p:sldId id="262" r:id="rId5"/>
    <p:sldId id="259" r:id="rId6"/>
    <p:sldId id="260" r:id="rId7"/>
    <p:sldId id="265" r:id="rId8"/>
    <p:sldId id="263" r:id="rId9"/>
    <p:sldId id="264" r:id="rId10"/>
  </p:sldIdLst>
  <p:sldSz cx="7772400" cy="100584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4C47083-DE37-4862-A302-3FB23C21D2D2}" v="2" dt="2026-04-24T10:06:59.08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52" autoAdjust="0"/>
    <p:restoredTop sz="94660"/>
  </p:normalViewPr>
  <p:slideViewPr>
    <p:cSldViewPr snapToGrid="0">
      <p:cViewPr>
        <p:scale>
          <a:sx n="75" d="100"/>
          <a:sy n="75" d="100"/>
        </p:scale>
        <p:origin x="1256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onika Shivale" userId="b30a8281-f4bb-4fe8-8dd2-4c2cd27b350c" providerId="ADAL" clId="{80EE1AA3-3498-47C7-9FE8-E5EE251B1734}"/>
    <pc:docChg chg="modSld">
      <pc:chgData name="Monika Shivale" userId="b30a8281-f4bb-4fe8-8dd2-4c2cd27b350c" providerId="ADAL" clId="{80EE1AA3-3498-47C7-9FE8-E5EE251B1734}" dt="2026-04-24T10:07:09.030" v="5" actId="20577"/>
      <pc:docMkLst>
        <pc:docMk/>
      </pc:docMkLst>
      <pc:sldChg chg="modSp mod">
        <pc:chgData name="Monika Shivale" userId="b30a8281-f4bb-4fe8-8dd2-4c2cd27b350c" providerId="ADAL" clId="{80EE1AA3-3498-47C7-9FE8-E5EE251B1734}" dt="2026-04-24T10:07:09.030" v="5" actId="20577"/>
        <pc:sldMkLst>
          <pc:docMk/>
          <pc:sldMk cId="1695822785" sldId="257"/>
        </pc:sldMkLst>
        <pc:spChg chg="mod">
          <ac:chgData name="Monika Shivale" userId="b30a8281-f4bb-4fe8-8dd2-4c2cd27b350c" providerId="ADAL" clId="{80EE1AA3-3498-47C7-9FE8-E5EE251B1734}" dt="2026-04-24T10:07:09.030" v="5" actId="20577"/>
          <ac:spMkLst>
            <pc:docMk/>
            <pc:sldMk cId="1695822785" sldId="257"/>
            <ac:spMk id="3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BDD7F-C96D-414B-9099-390F86F488D6}" type="datetimeFigureOut">
              <a:rPr lang="en-US" smtClean="0"/>
              <a:t>4/2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CB648-4801-4A40-9AAD-04A948C85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2847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BDD7F-C96D-414B-9099-390F86F488D6}" type="datetimeFigureOut">
              <a:rPr lang="en-US" smtClean="0"/>
              <a:t>4/2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CB648-4801-4A40-9AAD-04A948C85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497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BDD7F-C96D-414B-9099-390F86F488D6}" type="datetimeFigureOut">
              <a:rPr lang="en-US" smtClean="0"/>
              <a:t>4/2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CB648-4801-4A40-9AAD-04A948C85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6249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BDD7F-C96D-414B-9099-390F86F488D6}" type="datetimeFigureOut">
              <a:rPr lang="en-US" smtClean="0"/>
              <a:t>4/2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CB648-4801-4A40-9AAD-04A948C85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590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BDD7F-C96D-414B-9099-390F86F488D6}" type="datetimeFigureOut">
              <a:rPr lang="en-US" smtClean="0"/>
              <a:t>4/2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CB648-4801-4A40-9AAD-04A948C85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519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BDD7F-C96D-414B-9099-390F86F488D6}" type="datetimeFigureOut">
              <a:rPr lang="en-US" smtClean="0"/>
              <a:t>4/24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CB648-4801-4A40-9AAD-04A948C85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802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BDD7F-C96D-414B-9099-390F86F488D6}" type="datetimeFigureOut">
              <a:rPr lang="en-US" smtClean="0"/>
              <a:t>4/24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CB648-4801-4A40-9AAD-04A948C85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042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BDD7F-C96D-414B-9099-390F86F488D6}" type="datetimeFigureOut">
              <a:rPr lang="en-US" smtClean="0"/>
              <a:t>4/24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CB648-4801-4A40-9AAD-04A948C85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094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BDD7F-C96D-414B-9099-390F86F488D6}" type="datetimeFigureOut">
              <a:rPr lang="en-US" smtClean="0"/>
              <a:t>4/24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CB648-4801-4A40-9AAD-04A948C85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262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BDD7F-C96D-414B-9099-390F86F488D6}" type="datetimeFigureOut">
              <a:rPr lang="en-US" smtClean="0"/>
              <a:t>4/24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CB648-4801-4A40-9AAD-04A948C85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301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BDD7F-C96D-414B-9099-390F86F488D6}" type="datetimeFigureOut">
              <a:rPr lang="en-US" smtClean="0"/>
              <a:t>4/24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CB648-4801-4A40-9AAD-04A948C85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9432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FBDD7F-C96D-414B-9099-390F86F488D6}" type="datetimeFigureOut">
              <a:rPr lang="en-US" smtClean="0"/>
              <a:t>4/24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CB648-4801-4A40-9AAD-04A948C85B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13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Elena.Shagisultanova@ucdenver.edu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hyperlink" Target="https://dtp.cancer.gov/databases_tools/docs/compare/compare_methodology.htm" TargetMode="Externa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33400" y="801623"/>
            <a:ext cx="6473952" cy="6854065"/>
          </a:xfrm>
        </p:spPr>
        <p:txBody>
          <a:bodyPr>
            <a:noAutofit/>
          </a:bodyPr>
          <a:lstStyle/>
          <a:p>
            <a:pPr algn="just">
              <a:lnSpc>
                <a:spcPct val="170000"/>
              </a:lnSpc>
              <a:spcBef>
                <a:spcPts val="0"/>
              </a:spcBef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reast Cancer Research and Treatment</a:t>
            </a:r>
          </a:p>
          <a:p>
            <a:pPr algn="just">
              <a:lnSpc>
                <a:spcPct val="170000"/>
              </a:lnSpc>
              <a:spcBef>
                <a:spcPts val="0"/>
              </a:spcBef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mbined inhibition of aurora A and p21-activated kinase 1 as a new treatment strategy in breast cancer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70000"/>
              </a:lnSpc>
              <a:spcBef>
                <a:spcPts val="0"/>
              </a:spcBef>
            </a:pP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Vlad A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IN" sz="1200" dirty="0">
                <a:latin typeface="Arial" panose="020B0604020202020204" pitchFamily="34" charset="0"/>
                <a:cs typeface="Arial" panose="020B0604020202020204" pitchFamily="34" charset="0"/>
              </a:rPr>
              <a:t>Korben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,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Michelle Borakove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Yayi Feng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William M. Wuest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lex B. Koval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na S. Nikonova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Ilya Serebriiskii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, 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Jonathan Chernoff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Virginia F. Borges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Erica A. Golemis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Elena Shagisultanova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3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  <a:p>
            <a:pPr algn="just">
              <a:lnSpc>
                <a:spcPct val="170000"/>
              </a:lnSpc>
              <a:spcBef>
                <a:spcPts val="0"/>
              </a:spcBef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pPr algn="just">
              <a:lnSpc>
                <a:spcPct val="170000"/>
              </a:lnSpc>
              <a:spcBef>
                <a:spcPts val="0"/>
              </a:spcBef>
            </a:pP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partment of Pathology and Cell Biology, Columbia University College of Physicians and Surgeons, New York, NY, 10032; 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lecular Therapeutics Program, Fox Chase Cancer Center, Philadelphia, PA, 19111; 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iversity of Colorado Young Women’s Breast Cancer Translational Program, Aurora, CO, 80045; 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partment of Chemistry, Temple University, Philadelphia, PA, 19122; 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azan Federal University, Kazan, Russian Federation, 420000</a:t>
            </a:r>
          </a:p>
          <a:p>
            <a:pPr algn="just">
              <a:lnSpc>
                <a:spcPct val="170000"/>
              </a:lnSpc>
              <a:spcBef>
                <a:spcPts val="0"/>
              </a:spcBef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  <a:p>
            <a:pPr algn="just">
              <a:lnSpc>
                <a:spcPct val="170000"/>
              </a:lnSpc>
              <a:spcBef>
                <a:spcPts val="0"/>
              </a:spcBef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*Corresponding author: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lena Shagisultanova, MD, PhD; </a:t>
            </a:r>
          </a:p>
          <a:p>
            <a:pPr algn="just">
              <a:lnSpc>
                <a:spcPct val="170000"/>
              </a:lnSpc>
              <a:spcBef>
                <a:spcPts val="0"/>
              </a:spcBef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iling address: MS 8117, 12801 East 17th Ave, Room 8101A, Aurora, CO, 80045; Phone: 303-724-0083; fax: 303-724-3889; e-mail: </a:t>
            </a:r>
            <a:r>
              <a:rPr lang="en-US" sz="1200" u="sng" dirty="0">
                <a:latin typeface="Arial" panose="020B0604020202020204" pitchFamily="34" charset="0"/>
                <a:cs typeface="Arial" panose="020B0604020202020204" pitchFamily="34" charset="0"/>
                <a:hlinkClick r:id="rId2"/>
              </a:rPr>
              <a:t>Elena.Shagisultanova@ucdenver.edu</a:t>
            </a:r>
            <a:endParaRPr lang="en-US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70000"/>
              </a:lnSpc>
              <a:spcBef>
                <a:spcPts val="0"/>
              </a:spcBef>
            </a:pPr>
            <a:endParaRPr lang="en-US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70000"/>
              </a:lnSpc>
              <a:spcBef>
                <a:spcPts val="0"/>
              </a:spcBef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s S1 – S6 and Table S1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58227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453390" y="3673645"/>
            <a:ext cx="686562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 S1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rowth inhibition (GI) / lethal dose (LD) curves for alisertib, FRAX1036 and alisertib / FRAX1036 combination in representative breast tumor cell lines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combination treatment, alisertib and FRAX1036 were used at a constant 1.5:1 molar ratio. GI/LD curves were calculated according to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hlinkClick r:id="rId2"/>
              </a:rPr>
              <a:t>https://dtp.cancer.gov/databases_tools/docs/compare/compare_methodology.htm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55722"/>
            <a:ext cx="7772400" cy="32558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09540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64820" y="5816209"/>
            <a:ext cx="686562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 S2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anges of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C50 of alisertib and FRAX1036 used as monoagents and in combination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ata presented as mean IC50 (µM)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± SEM in luminal (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HR-/HER2+ (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TNBC (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cell lines. Cell lines where the combination showed synergy are underlined. In combination treatment, alisertib and FRAX1036 were used at a constant 1.5:1 molar ratio 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330" y="614260"/>
            <a:ext cx="7772400" cy="49212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11900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36711"/>
            <a:ext cx="7772400" cy="195403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68050" y="2471125"/>
            <a:ext cx="686562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 S3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ctivity of alisertib and FRAX1036 in luminal cell lines comparing to fulvestrant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s were cultured in estradiol free conditions (charcoal stripped serum and phenol red free media) for 3 days prior to plating in 96 wells plates. Twenty-four hours after plating, the drugs were added and the cells were treated for 96 hours. Cell viability was measured b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Tit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Glow (CTG) assay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combination treatment, alisertib and FRAX1036 were used at a constant 1.5:1 molar ratio 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53690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59489" y="8180963"/>
            <a:ext cx="723350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4.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ime course of changes in cell cycle of BT474 cells after treatment with vehicle, alisertib, FRAX1036, and combination.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sterisks mark significant differences (p≤0.05) in the proportion of cells in phases of cell cycle between treatment groups versus vehicle by one-way ANOVA. 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4084"/>
            <a:ext cx="7772400" cy="80468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79638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220980" y="8561057"/>
            <a:ext cx="714908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5.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ime course of changes in cell cycle of T47D cells after treatment with vehicle, alisertib, FRAX1036, and combination.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sterisks mark significant differences (p≤0.05) in the proportion of cells in phases of cell cycle between treatment groups versus vehicle by one-way ANOVA. 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75551"/>
            <a:ext cx="7772400" cy="81855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42111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97180"/>
            <a:ext cx="7772400" cy="4072228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11658" y="4488180"/>
            <a:ext cx="714908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6. Alisertib alone and in combination inhibits phosphorylation of AURKA substrate polo-like kinase 1 (PLK) in BT474 cell line. 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– total PLK1,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– phospho-PLK1 (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r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10); V – vehicle, A – alisertib, F – FRAX1036, A+F – alisertib and FRAX1036; ** p&lt;0.05 by two-tail t-test. 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58318" y="14030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961638" y="15554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1027263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459" y="83820"/>
            <a:ext cx="6712760" cy="865632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93777" y="8831580"/>
            <a:ext cx="714908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S7. METABRIC analysis.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erall survival of patients with co-alterations in AURKA and PAK1, 2 or 3 (either amplification, or expression level increased ≥3 times over baseline occurring simultaneously in AURKA and PAK1, 2, or 3) comparing to patients without alterations in AURKA and / or PAK 1, 2, 3.  </a:t>
            </a:r>
            <a:endParaRPr lang="en-US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616965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6869" y="457200"/>
            <a:ext cx="7178662" cy="6172735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296869" y="6809249"/>
            <a:ext cx="7200900" cy="4875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S1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e way ANOVA and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ruskal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Wallis test results for parameters presented on Figs. 2-5; V- vehicle, A – alisertib, F – FRAX1036, A+F – alisertib and FRAX1036 combination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53276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</TotalTime>
  <Words>719</Words>
  <Application>Microsoft Office PowerPoint</Application>
  <PresentationFormat>Custom</PresentationFormat>
  <Paragraphs>20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ena Shagisultanova</dc:creator>
  <cp:lastModifiedBy>Monika Shivale</cp:lastModifiedBy>
  <cp:revision>30</cp:revision>
  <cp:lastPrinted>2018-11-05T05:54:24Z</cp:lastPrinted>
  <dcterms:created xsi:type="dcterms:W3CDTF">2018-04-18T23:01:01Z</dcterms:created>
  <dcterms:modified xsi:type="dcterms:W3CDTF">2026-04-24T10:07:18Z</dcterms:modified>
</cp:coreProperties>
</file>